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28600" y="838200"/>
            <a:ext cx="10058400" cy="4724400"/>
            <a:chOff x="-990600" y="240268"/>
            <a:chExt cx="11163300" cy="5208032"/>
          </a:xfrm>
        </p:grpSpPr>
        <p:sp>
          <p:nvSpPr>
            <p:cNvPr id="5" name="TextBox 4"/>
            <p:cNvSpPr txBox="1"/>
            <p:nvPr/>
          </p:nvSpPr>
          <p:spPr>
            <a:xfrm>
              <a:off x="-76200" y="240268"/>
              <a:ext cx="5082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IN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-990600" y="468868"/>
              <a:ext cx="11163300" cy="4979432"/>
              <a:chOff x="-990600" y="468868"/>
              <a:chExt cx="11163300" cy="4979432"/>
            </a:xfrm>
          </p:grpSpPr>
          <p:pic>
            <p:nvPicPr>
              <p:cNvPr id="8" name="Picture 2" descr="C:\Users\Showkat\Dropbox\miRNA Wild rice data\All in One\MS\miR528-Alignment (non-conserved miRNA).pn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5611" y="826532"/>
                <a:ext cx="8963025" cy="21717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3" descr="C:\Users\Showkat\Dropbox\miRNA Wild rice data\All in One\MS\miR393a-Alignment (Conserved miRNA).pn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990600" y="3276600"/>
                <a:ext cx="11163300" cy="21717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" name="Straight Connector 9"/>
              <p:cNvCxnSpPr/>
              <p:nvPr/>
            </p:nvCxnSpPr>
            <p:spPr>
              <a:xfrm>
                <a:off x="1219200" y="824345"/>
                <a:ext cx="2590800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3886200" y="824345"/>
                <a:ext cx="5181600" cy="2187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1219200" y="468868"/>
                <a:ext cx="2438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itchFamily="18" charset="0"/>
                    <a:cs typeface="Times New Roman" pitchFamily="18" charset="0"/>
                  </a:rPr>
                  <a:t>More conserved region</a:t>
                </a:r>
                <a:endParaRPr lang="en-IN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334000" y="468868"/>
                <a:ext cx="2514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itchFamily="18" charset="0"/>
                    <a:cs typeface="Times New Roman" pitchFamily="18" charset="0"/>
                  </a:rPr>
                  <a:t>Less conserved region</a:t>
                </a:r>
                <a:endParaRPr lang="en-IN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152400" y="3276600"/>
                <a:ext cx="2984789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381000" y="2983468"/>
                <a:ext cx="2438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itchFamily="18" charset="0"/>
                    <a:cs typeface="Times New Roman" pitchFamily="18" charset="0"/>
                  </a:rPr>
                  <a:t>More conserved region</a:t>
                </a:r>
                <a:endParaRPr lang="en-IN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6" name="Straight Connector 15"/>
              <p:cNvCxnSpPr/>
              <p:nvPr/>
            </p:nvCxnSpPr>
            <p:spPr>
              <a:xfrm>
                <a:off x="3352800" y="3276600"/>
                <a:ext cx="6477000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5257800" y="2983468"/>
                <a:ext cx="2514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itchFamily="18" charset="0"/>
                    <a:cs typeface="Times New Roman" pitchFamily="18" charset="0"/>
                  </a:rPr>
                  <a:t>Less conserved region</a:t>
                </a:r>
                <a:endParaRPr lang="en-IN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-76200" y="2590800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IN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4565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7200" y="2133600"/>
            <a:ext cx="80772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20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sz="20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Sequence conservation in </a:t>
            </a:r>
            <a:r>
              <a:rPr lang="en-IN" sz="2000" dirty="0" smtClean="0">
                <a:latin typeface="Times New Roman" pitchFamily="18" charset="0"/>
                <a:cs typeface="Times New Roman" pitchFamily="18" charset="0"/>
              </a:rPr>
              <a:t>the precursors of non-conserved miR528  (A)and conserved miR393a (B) among the </a:t>
            </a:r>
            <a:r>
              <a:rPr lang="en-IN" sz="20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sz="2000" dirty="0" smtClean="0">
                <a:latin typeface="Times New Roman" pitchFamily="18" charset="0"/>
                <a:cs typeface="Times New Roman" pitchFamily="18" charset="0"/>
              </a:rPr>
              <a:t> species. It can be seen from the alignments that sequence regions around the mature sequence are more conserved than other regions in the precursors of both </a:t>
            </a:r>
            <a:r>
              <a:rPr lang="en-IN" sz="2000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r>
              <a:rPr lang="en-IN" sz="20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Multiple sequence alignment of FLZ proteins of selected species is generated using CLUSTAL X and visualized in </a:t>
            </a:r>
            <a:r>
              <a:rPr lang="en-IN" sz="2000" dirty="0" err="1">
                <a:latin typeface="Times New Roman" pitchFamily="18" charset="0"/>
                <a:cs typeface="Times New Roman" pitchFamily="18" charset="0"/>
              </a:rPr>
              <a:t>Jalview</a:t>
            </a:r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24156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3</Words>
  <Application>Microsoft Office PowerPoint</Application>
  <PresentationFormat>On-screen Show (4:3)</PresentationFormat>
  <Paragraphs>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7</cp:revision>
  <dcterms:created xsi:type="dcterms:W3CDTF">2006-08-16T00:00:00Z</dcterms:created>
  <dcterms:modified xsi:type="dcterms:W3CDTF">2017-08-30T15:15:50Z</dcterms:modified>
</cp:coreProperties>
</file>